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Override PartName="/ppt/slideLayouts/slideLayout10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74" d="100"/>
          <a:sy n="74" d="100"/>
        </p:scale>
        <p:origin x="-396" y="12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A5D9AD-314B-4EA9-9EC7-1332B417ECA1}" type="datetimeFigureOut">
              <a:rPr lang="en-US" smtClean="0"/>
              <a:pPr/>
              <a:t>15/11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16BD58-2716-40DC-8C94-023F9E34269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42895259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A5D9AD-314B-4EA9-9EC7-1332B417ECA1}" type="datetimeFigureOut">
              <a:rPr lang="en-US" smtClean="0"/>
              <a:pPr/>
              <a:t>15/11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16BD58-2716-40DC-8C94-023F9E34269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9289100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A5D9AD-314B-4EA9-9EC7-1332B417ECA1}" type="datetimeFigureOut">
              <a:rPr lang="en-US" smtClean="0"/>
              <a:pPr/>
              <a:t>15/11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16BD58-2716-40DC-8C94-023F9E34269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159525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A5D9AD-314B-4EA9-9EC7-1332B417ECA1}" type="datetimeFigureOut">
              <a:rPr lang="en-US" smtClean="0"/>
              <a:pPr/>
              <a:t>15/11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16BD58-2716-40DC-8C94-023F9E34269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41654620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A5D9AD-314B-4EA9-9EC7-1332B417ECA1}" type="datetimeFigureOut">
              <a:rPr lang="en-US" smtClean="0"/>
              <a:pPr/>
              <a:t>15/11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16BD58-2716-40DC-8C94-023F9E34269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61095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A5D9AD-314B-4EA9-9EC7-1332B417ECA1}" type="datetimeFigureOut">
              <a:rPr lang="en-US" smtClean="0"/>
              <a:pPr/>
              <a:t>15/11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16BD58-2716-40DC-8C94-023F9E34269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1174752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A5D9AD-314B-4EA9-9EC7-1332B417ECA1}" type="datetimeFigureOut">
              <a:rPr lang="en-US" smtClean="0"/>
              <a:pPr/>
              <a:t>15/11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16BD58-2716-40DC-8C94-023F9E34269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2626787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A5D9AD-314B-4EA9-9EC7-1332B417ECA1}" type="datetimeFigureOut">
              <a:rPr lang="en-US" smtClean="0"/>
              <a:pPr/>
              <a:t>15/11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16BD58-2716-40DC-8C94-023F9E34269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669273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A5D9AD-314B-4EA9-9EC7-1332B417ECA1}" type="datetimeFigureOut">
              <a:rPr lang="en-US" smtClean="0"/>
              <a:pPr/>
              <a:t>15/11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16BD58-2716-40DC-8C94-023F9E34269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2330286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A5D9AD-314B-4EA9-9EC7-1332B417ECA1}" type="datetimeFigureOut">
              <a:rPr lang="en-US" smtClean="0"/>
              <a:pPr/>
              <a:t>15/11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16BD58-2716-40DC-8C94-023F9E34269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40830182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A5D9AD-314B-4EA9-9EC7-1332B417ECA1}" type="datetimeFigureOut">
              <a:rPr lang="en-US" smtClean="0"/>
              <a:pPr/>
              <a:t>15/11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16BD58-2716-40DC-8C94-023F9E34269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4602441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A5D9AD-314B-4EA9-9EC7-1332B417ECA1}" type="datetimeFigureOut">
              <a:rPr lang="en-US" smtClean="0"/>
              <a:pPr/>
              <a:t>15/11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16BD58-2716-40DC-8C94-023F9E34269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6615182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495300" y="209550"/>
            <a:ext cx="8153400" cy="611505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0" y="6406891"/>
            <a:ext cx="9144000" cy="520931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981200" y="6534090"/>
            <a:ext cx="558152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 err="1" smtClean="0"/>
              <a:t>Wandschneider</a:t>
            </a:r>
            <a:r>
              <a:rPr lang="en-US" sz="2000" dirty="0" smtClean="0"/>
              <a:t> et al, 2013, DOI</a:t>
            </a:r>
            <a:r>
              <a:rPr lang="en-US" sz="2000" dirty="0"/>
              <a:t>: 10.1111/epi.12413</a:t>
            </a:r>
          </a:p>
        </p:txBody>
      </p:sp>
      <p:sp>
        <p:nvSpPr>
          <p:cNvPr id="7" name="Rectangle 6"/>
          <p:cNvSpPr/>
          <p:nvPr/>
        </p:nvSpPr>
        <p:spPr>
          <a:xfrm>
            <a:off x="1676400" y="6743605"/>
            <a:ext cx="6248400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050" dirty="0" smtClean="0"/>
              <a:t>This material is copyrighted by the author(s) and provided as a courtesy for non-commercial educational use</a:t>
            </a:r>
            <a:endParaRPr lang="en-US" sz="1050" dirty="0"/>
          </a:p>
        </p:txBody>
      </p:sp>
    </p:spTree>
    <p:extLst>
      <p:ext uri="{BB962C8B-B14F-4D97-AF65-F5344CB8AC3E}">
        <p14:creationId xmlns:p14="http://schemas.microsoft.com/office/powerpoint/2010/main" xmlns="" val="25864607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26</Words>
  <Application>Microsoft Office PowerPoint</Application>
  <PresentationFormat>On-screen Show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Hewlett-Packard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aurie</dc:creator>
  <cp:lastModifiedBy>wbworkflow</cp:lastModifiedBy>
  <cp:revision>3</cp:revision>
  <dcterms:created xsi:type="dcterms:W3CDTF">2013-10-24T21:11:33Z</dcterms:created>
  <dcterms:modified xsi:type="dcterms:W3CDTF">2013-11-15T10:28:19Z</dcterms:modified>
  <cp:contentStatus>Final</cp:contentStatus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_MarkAsFinal">
    <vt:bool>true</vt:bool>
  </property>
</Properties>
</file>